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9" r:id="rId2"/>
  </p:sldIdLst>
  <p:sldSz cx="6858000" cy="9144000" type="screen4x3"/>
  <p:notesSz cx="6888163" cy="100187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157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wrin, Christian" initials="MC" lastIdx="1" clrIdx="0">
    <p:extLst>
      <p:ext uri="{19B8F6BF-5375-455C-9EA6-DF929625EA0E}">
        <p15:presenceInfo xmlns:p15="http://schemas.microsoft.com/office/powerpoint/2012/main" userId="Mawrin, Christia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911" autoAdjust="0"/>
    <p:restoredTop sz="95256" autoAdjust="0"/>
  </p:normalViewPr>
  <p:slideViewPr>
    <p:cSldViewPr showGuides="1">
      <p:cViewPr>
        <p:scale>
          <a:sx n="102" d="100"/>
          <a:sy n="102" d="100"/>
        </p:scale>
        <p:origin x="2122" y="-1090"/>
      </p:cViewPr>
      <p:guideLst>
        <p:guide orient="horz" pos="2880"/>
        <p:guide pos="157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902075" y="0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9792FE-BD17-42CA-8A93-7788847EEED1}" type="datetimeFigureOut">
              <a:rPr lang="en-DE" smtClean="0"/>
              <a:t>01/22/2026</a:t>
            </a:fld>
            <a:endParaRPr lang="en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76463" y="1252538"/>
            <a:ext cx="2535237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8975" y="4821238"/>
            <a:ext cx="5510213" cy="39449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517063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902075" y="9517063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5A873A4-4519-4784-B7D0-0C671E3BEE03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5751325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967175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74414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19125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08013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55663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57162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917208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606618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22971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858922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222388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60400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jpg"/><Relationship Id="rId13" Type="http://schemas.openxmlformats.org/officeDocument/2006/relationships/oleObject" Target="../embeddings/oleObject3.bin"/><Relationship Id="rId18" Type="http://schemas.openxmlformats.org/officeDocument/2006/relationships/image" Target="../media/image5.emf"/><Relationship Id="rId3" Type="http://schemas.openxmlformats.org/officeDocument/2006/relationships/image" Target="../media/image6.jpeg"/><Relationship Id="rId7" Type="http://schemas.openxmlformats.org/officeDocument/2006/relationships/image" Target="../media/image10.jpg"/><Relationship Id="rId12" Type="http://schemas.openxmlformats.org/officeDocument/2006/relationships/image" Target="../media/image2.emf"/><Relationship Id="rId17" Type="http://schemas.openxmlformats.org/officeDocument/2006/relationships/oleObject" Target="../embeddings/oleObject5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4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9.jpg"/><Relationship Id="rId11" Type="http://schemas.openxmlformats.org/officeDocument/2006/relationships/oleObject" Target="../embeddings/oleObject2.bin"/><Relationship Id="rId5" Type="http://schemas.openxmlformats.org/officeDocument/2006/relationships/image" Target="../media/image8.jpeg"/><Relationship Id="rId15" Type="http://schemas.openxmlformats.org/officeDocument/2006/relationships/oleObject" Target="../embeddings/oleObject4.bin"/><Relationship Id="rId10" Type="http://schemas.openxmlformats.org/officeDocument/2006/relationships/image" Target="../media/image1.emf"/><Relationship Id="rId4" Type="http://schemas.openxmlformats.org/officeDocument/2006/relationships/image" Target="../media/image7.jpg"/><Relationship Id="rId9" Type="http://schemas.openxmlformats.org/officeDocument/2006/relationships/oleObject" Target="../embeddings/oleObject1.bin"/><Relationship Id="rId1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413AFA00-7B14-FCDE-73A9-0E2BD18B2466}"/>
              </a:ext>
            </a:extLst>
          </p:cNvPr>
          <p:cNvSpPr txBox="1"/>
          <p:nvPr/>
        </p:nvSpPr>
        <p:spPr>
          <a:xfrm>
            <a:off x="333978" y="104558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D14BD27D-184F-F6E0-1922-48EF1DDB955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2696" y="1910240"/>
            <a:ext cx="1080000" cy="24310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761ECAF7-992F-4E77-AD4A-D3639562067A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2696" y="2197320"/>
            <a:ext cx="1080000" cy="14616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38C96928-7E86-5CF3-586C-0AD8750C2BC5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95401" y="1924888"/>
            <a:ext cx="1080000" cy="17617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73783405-BF63-482E-6130-425C88713791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95401" y="2135997"/>
            <a:ext cx="1080000" cy="16102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Grafik 8">
            <a:extLst>
              <a:ext uri="{FF2B5EF4-FFF2-40B4-BE49-F238E27FC236}">
                <a16:creationId xmlns:a16="http://schemas.microsoft.com/office/drawing/2014/main" id="{D364285C-87C5-1558-4045-743919E71E75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3962" y="1897801"/>
            <a:ext cx="1080000" cy="25144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5C8A49C1-107C-B249-D860-741CFC74A299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3962" y="2183107"/>
            <a:ext cx="1080000" cy="16836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Textfeld 10">
            <a:extLst>
              <a:ext uri="{FF2B5EF4-FFF2-40B4-BE49-F238E27FC236}">
                <a16:creationId xmlns:a16="http://schemas.microsoft.com/office/drawing/2014/main" id="{E689F42C-AF5A-C9D9-F75D-F7134DC0CD8E}"/>
              </a:ext>
            </a:extLst>
          </p:cNvPr>
          <p:cNvSpPr txBox="1"/>
          <p:nvPr/>
        </p:nvSpPr>
        <p:spPr>
          <a:xfrm>
            <a:off x="1776822" y="2147293"/>
            <a:ext cx="7053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 ß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031EC12B-FFC8-0F56-287A-65E93A3F24E5}"/>
              </a:ext>
            </a:extLst>
          </p:cNvPr>
          <p:cNvSpPr txBox="1"/>
          <p:nvPr/>
        </p:nvSpPr>
        <p:spPr>
          <a:xfrm>
            <a:off x="1768153" y="1842728"/>
            <a:ext cx="6320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 LC3-I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6D2947D5-8C8C-2EF3-A4E8-E2A310591EF7}"/>
              </a:ext>
            </a:extLst>
          </p:cNvPr>
          <p:cNvSpPr txBox="1"/>
          <p:nvPr/>
        </p:nvSpPr>
        <p:spPr>
          <a:xfrm>
            <a:off x="1772279" y="1970287"/>
            <a:ext cx="6779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 LC3-II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58C7FA59-7289-4471-B19D-5154F3DFF99E}"/>
              </a:ext>
            </a:extLst>
          </p:cNvPr>
          <p:cNvSpPr txBox="1"/>
          <p:nvPr/>
        </p:nvSpPr>
        <p:spPr>
          <a:xfrm rot="18900000">
            <a:off x="673732" y="1505889"/>
            <a:ext cx="7880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U138 SCR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1D84D8AB-DB57-DB5E-5E5C-6AD00CFBFFCF}"/>
              </a:ext>
            </a:extLst>
          </p:cNvPr>
          <p:cNvSpPr txBox="1"/>
          <p:nvPr/>
        </p:nvSpPr>
        <p:spPr>
          <a:xfrm rot="18900000">
            <a:off x="981796" y="1407792"/>
            <a:ext cx="1079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U138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RagC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KO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1D305A41-862F-D64E-4B02-C71260F07002}"/>
              </a:ext>
            </a:extLst>
          </p:cNvPr>
          <p:cNvSpPr txBox="1"/>
          <p:nvPr/>
        </p:nvSpPr>
        <p:spPr>
          <a:xfrm rot="18900000">
            <a:off x="1309181" y="1356743"/>
            <a:ext cx="12169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U138 Map4K3 KO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3C73B1DA-2D10-8723-F048-8A36D823B733}"/>
              </a:ext>
            </a:extLst>
          </p:cNvPr>
          <p:cNvSpPr txBox="1"/>
          <p:nvPr/>
        </p:nvSpPr>
        <p:spPr>
          <a:xfrm>
            <a:off x="3775401" y="2081884"/>
            <a:ext cx="7053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 ß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20A01C20-BDB6-4CFA-3C4A-72C9468843C3}"/>
              </a:ext>
            </a:extLst>
          </p:cNvPr>
          <p:cNvSpPr txBox="1"/>
          <p:nvPr/>
        </p:nvSpPr>
        <p:spPr>
          <a:xfrm>
            <a:off x="3777327" y="1814272"/>
            <a:ext cx="6320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 LC3-I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DE7D0A02-8EAD-C6F0-E1D4-9CB077EF3791}"/>
              </a:ext>
            </a:extLst>
          </p:cNvPr>
          <p:cNvSpPr txBox="1"/>
          <p:nvPr/>
        </p:nvSpPr>
        <p:spPr>
          <a:xfrm>
            <a:off x="3781453" y="1941831"/>
            <a:ext cx="6779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 LC3-II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F049D56B-4E2C-00FB-7F2B-9FC139AF06A0}"/>
              </a:ext>
            </a:extLst>
          </p:cNvPr>
          <p:cNvSpPr txBox="1"/>
          <p:nvPr/>
        </p:nvSpPr>
        <p:spPr>
          <a:xfrm rot="18900000">
            <a:off x="2643078" y="1479785"/>
            <a:ext cx="8939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MCF-7 SCR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7B83A712-F7E7-979C-05E6-4C85CDBD198B}"/>
              </a:ext>
            </a:extLst>
          </p:cNvPr>
          <p:cNvSpPr txBox="1"/>
          <p:nvPr/>
        </p:nvSpPr>
        <p:spPr>
          <a:xfrm rot="18900000">
            <a:off x="2940924" y="1358849"/>
            <a:ext cx="1231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MCF-7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RagC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KO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485E9EB3-CA9E-E93A-323A-49D9A8465097}"/>
              </a:ext>
            </a:extLst>
          </p:cNvPr>
          <p:cNvSpPr txBox="1"/>
          <p:nvPr/>
        </p:nvSpPr>
        <p:spPr>
          <a:xfrm rot="18900000">
            <a:off x="3280781" y="1313371"/>
            <a:ext cx="13602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MCF-7 Map4K3 KO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DCBD6107-0B57-9FED-3FD3-9EB730638F4C}"/>
              </a:ext>
            </a:extLst>
          </p:cNvPr>
          <p:cNvSpPr txBox="1"/>
          <p:nvPr/>
        </p:nvSpPr>
        <p:spPr>
          <a:xfrm>
            <a:off x="5829567" y="2134233"/>
            <a:ext cx="7053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 ß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3E4F7256-81D6-2A85-265E-7647E3212D17}"/>
              </a:ext>
            </a:extLst>
          </p:cNvPr>
          <p:cNvSpPr txBox="1"/>
          <p:nvPr/>
        </p:nvSpPr>
        <p:spPr>
          <a:xfrm>
            <a:off x="5827189" y="1839231"/>
            <a:ext cx="6320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 LC3-I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2380901C-2B7B-D8A2-E789-2DA4EBC6F4B0}"/>
              </a:ext>
            </a:extLst>
          </p:cNvPr>
          <p:cNvSpPr txBox="1"/>
          <p:nvPr/>
        </p:nvSpPr>
        <p:spPr>
          <a:xfrm>
            <a:off x="5828017" y="1948754"/>
            <a:ext cx="6779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 LC3-II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E137892C-F1D7-E088-09DB-6109500576A4}"/>
              </a:ext>
            </a:extLst>
          </p:cNvPr>
          <p:cNvSpPr txBox="1"/>
          <p:nvPr/>
        </p:nvSpPr>
        <p:spPr>
          <a:xfrm rot="18900000">
            <a:off x="4715370" y="1481104"/>
            <a:ext cx="8602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IOMM SCR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61B19DAB-2597-55E6-A1C5-7F3F318BBF55}"/>
              </a:ext>
            </a:extLst>
          </p:cNvPr>
          <p:cNvSpPr txBox="1"/>
          <p:nvPr/>
        </p:nvSpPr>
        <p:spPr>
          <a:xfrm rot="18900000">
            <a:off x="4994912" y="1379795"/>
            <a:ext cx="11204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IOMM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RagC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KO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17369EF0-C7FA-12DF-AE93-2815B2A935F6}"/>
              </a:ext>
            </a:extLst>
          </p:cNvPr>
          <p:cNvSpPr txBox="1"/>
          <p:nvPr/>
        </p:nvSpPr>
        <p:spPr>
          <a:xfrm rot="18900000">
            <a:off x="5330129" y="1328765"/>
            <a:ext cx="12884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IOMM Map4K3 KO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307C5F2B-6518-BCFD-0F91-82BD0C3A1F2A}"/>
              </a:ext>
            </a:extLst>
          </p:cNvPr>
          <p:cNvSpPr txBox="1"/>
          <p:nvPr/>
        </p:nvSpPr>
        <p:spPr>
          <a:xfrm>
            <a:off x="332656" y="611560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  <p:graphicFrame>
        <p:nvGraphicFramePr>
          <p:cNvPr id="3" name="Objekt 2">
            <a:extLst>
              <a:ext uri="{FF2B5EF4-FFF2-40B4-BE49-F238E27FC236}">
                <a16:creationId xmlns:a16="http://schemas.microsoft.com/office/drawing/2014/main" id="{29E8C1BC-4F99-DCB7-9E01-F50A3FAEE02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91954976"/>
              </p:ext>
            </p:extLst>
          </p:nvPr>
        </p:nvGraphicFramePr>
        <p:xfrm>
          <a:off x="2909127" y="2293598"/>
          <a:ext cx="720000" cy="13025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59" name="Prism 8" r:id="rId9" imgW="1962831" imgH="3548862" progId="Prism8.Document">
                  <p:embed/>
                </p:oleObj>
              </mc:Choice>
              <mc:Fallback>
                <p:oleObj name="Prism 8" r:id="rId9" imgW="1962831" imgH="3548862" progId="Prism8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0AB1031D-E204-FA60-46BF-7CCED0DC0C6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909127" y="2293598"/>
                        <a:ext cx="720000" cy="13025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9" name="Objekt 38">
            <a:extLst>
              <a:ext uri="{FF2B5EF4-FFF2-40B4-BE49-F238E27FC236}">
                <a16:creationId xmlns:a16="http://schemas.microsoft.com/office/drawing/2014/main" id="{1545F314-B6F9-42AE-BCF1-A1E45408538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65390708"/>
              </p:ext>
            </p:extLst>
          </p:nvPr>
        </p:nvGraphicFramePr>
        <p:xfrm>
          <a:off x="676892" y="2361467"/>
          <a:ext cx="720000" cy="11887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60" name="Prism 8" r:id="rId11" imgW="1965710" imgH="3244334" progId="Prism8.Document">
                  <p:embed/>
                </p:oleObj>
              </mc:Choice>
              <mc:Fallback>
                <p:oleObj name="Prism 8" r:id="rId11" imgW="1965710" imgH="3244334" progId="Prism8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6B4DEF59-257C-0C47-2362-691573DDA92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676892" y="2361467"/>
                        <a:ext cx="720000" cy="11887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1" name="Objekt 40">
            <a:extLst>
              <a:ext uri="{FF2B5EF4-FFF2-40B4-BE49-F238E27FC236}">
                <a16:creationId xmlns:a16="http://schemas.microsoft.com/office/drawing/2014/main" id="{867BF55D-E78E-EC22-178C-A596FC1D61D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70436707"/>
              </p:ext>
            </p:extLst>
          </p:nvPr>
        </p:nvGraphicFramePr>
        <p:xfrm>
          <a:off x="1424284" y="2360505"/>
          <a:ext cx="720000" cy="11906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61" name="Prism 8" r:id="rId13" imgW="1962831" imgH="3244334" progId="Prism8.Document">
                  <p:embed/>
                </p:oleObj>
              </mc:Choice>
              <mc:Fallback>
                <p:oleObj name="Prism 8" r:id="rId13" imgW="1962831" imgH="3244334" progId="Prism8.Document">
                  <p:embed/>
                  <p:pic>
                    <p:nvPicPr>
                      <p:cNvPr id="3" name="Objekt 2">
                        <a:extLst>
                          <a:ext uri="{FF2B5EF4-FFF2-40B4-BE49-F238E27FC236}">
                            <a16:creationId xmlns:a16="http://schemas.microsoft.com/office/drawing/2014/main" id="{1A70C732-3491-E88E-2CAA-1735407144E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1424284" y="2360505"/>
                        <a:ext cx="720000" cy="11906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2" name="Objekt 41">
            <a:extLst>
              <a:ext uri="{FF2B5EF4-FFF2-40B4-BE49-F238E27FC236}">
                <a16:creationId xmlns:a16="http://schemas.microsoft.com/office/drawing/2014/main" id="{509DD46D-20CC-4F8D-A2D9-2E78D034D60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52746235"/>
              </p:ext>
            </p:extLst>
          </p:nvPr>
        </p:nvGraphicFramePr>
        <p:xfrm>
          <a:off x="4746765" y="2380454"/>
          <a:ext cx="720000" cy="12009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62" name="Prism 8" r:id="rId15" imgW="1965710" imgH="3277810" progId="Prism8.Document">
                  <p:embed/>
                </p:oleObj>
              </mc:Choice>
              <mc:Fallback>
                <p:oleObj name="Prism 8" r:id="rId15" imgW="1965710" imgH="3277810" progId="Prism8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D13BBAAE-CCC7-5366-F772-24CA7099167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4746765" y="2380454"/>
                        <a:ext cx="720000" cy="12009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4" name="Objekt 43">
            <a:extLst>
              <a:ext uri="{FF2B5EF4-FFF2-40B4-BE49-F238E27FC236}">
                <a16:creationId xmlns:a16="http://schemas.microsoft.com/office/drawing/2014/main" id="{3605DAE0-B45B-8AB3-0863-5994E67CFE0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00975377"/>
              </p:ext>
            </p:extLst>
          </p:nvPr>
        </p:nvGraphicFramePr>
        <p:xfrm>
          <a:off x="5446992" y="2378510"/>
          <a:ext cx="720000" cy="1202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63" name="Prism 8" r:id="rId17" imgW="1962831" imgH="3277810" progId="Prism8.Document">
                  <p:embed/>
                </p:oleObj>
              </mc:Choice>
              <mc:Fallback>
                <p:oleObj name="Prism 8" r:id="rId17" imgW="1962831" imgH="3277810" progId="Prism8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2C8F4C7A-2FED-FD61-A6B7-0856C7404E2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5446992" y="2378510"/>
                        <a:ext cx="720000" cy="12029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echteck 1"/>
          <p:cNvSpPr/>
          <p:nvPr/>
        </p:nvSpPr>
        <p:spPr>
          <a:xfrm>
            <a:off x="593642" y="4283968"/>
            <a:ext cx="5968303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Figure S4 </a:t>
            </a:r>
            <a:r>
              <a:rPr lang="en-US" sz="1200" dirty="0"/>
              <a:t>Knockout of Map4K3 and </a:t>
            </a:r>
            <a:r>
              <a:rPr lang="en-US" sz="1200" dirty="0" err="1"/>
              <a:t>RagC</a:t>
            </a:r>
            <a:r>
              <a:rPr lang="en-US" sz="1200" dirty="0"/>
              <a:t> leads to autophagy induction</a:t>
            </a:r>
          </a:p>
          <a:p>
            <a:r>
              <a:rPr lang="en-US" sz="1200" dirty="0"/>
              <a:t>Expression of LC3 in </a:t>
            </a:r>
            <a:r>
              <a:rPr lang="en-US" sz="1200" dirty="0" err="1"/>
              <a:t>RagC</a:t>
            </a:r>
            <a:r>
              <a:rPr lang="en-US" sz="1200" dirty="0"/>
              <a:t> or Map4K3 deficient U138, MCF-7 and IOMM-Lee cells. The ratio of investigated antibodies to ß-actin was determined by densitometry using </a:t>
            </a:r>
            <a:r>
              <a:rPr lang="en-US" sz="1200" dirty="0" err="1"/>
              <a:t>ImageJ</a:t>
            </a:r>
            <a:r>
              <a:rPr lang="en-US" sz="12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916979546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5</Words>
  <Application>Microsoft Office PowerPoint</Application>
  <PresentationFormat>Bildschirmpräsentation (4:3)</PresentationFormat>
  <Paragraphs>22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Larissa</vt:lpstr>
      <vt:lpstr>Prism 8</vt:lpstr>
      <vt:lpstr>PowerPoint-Präsentation</vt:lpstr>
    </vt:vector>
  </TitlesOfParts>
  <Company>Universitätsklinikum Magdeburg A.ö.R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aldt, Natalie</dc:creator>
  <cp:lastModifiedBy>Mawrin, Christian</cp:lastModifiedBy>
  <cp:revision>169</cp:revision>
  <cp:lastPrinted>2019-07-11T11:27:03Z</cp:lastPrinted>
  <dcterms:created xsi:type="dcterms:W3CDTF">2018-06-15T09:59:45Z</dcterms:created>
  <dcterms:modified xsi:type="dcterms:W3CDTF">2026-01-22T20:30:44Z</dcterms:modified>
</cp:coreProperties>
</file>